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gif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1,10-Phenanthroline ≥99% | 66-71-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880" y="636828"/>
            <a:ext cx="1256487" cy="7322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587228" y="471545"/>
            <a:ext cx="2109873" cy="27424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457200" marR="0">
              <a:lnSpc>
                <a:spcPct val="106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10-phenanthroline</a:t>
            </a:r>
          </a:p>
        </p:txBody>
      </p:sp>
      <p:pic>
        <p:nvPicPr>
          <p:cNvPr id="5" name="Picture 4" descr="ACY-1215 inhibitor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85" y="1511835"/>
            <a:ext cx="2805896" cy="13637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/>
          <p:cNvSpPr/>
          <p:nvPr/>
        </p:nvSpPr>
        <p:spPr>
          <a:xfrm>
            <a:off x="967260" y="1684458"/>
            <a:ext cx="1352806" cy="27424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457200" marR="0">
              <a:lnSpc>
                <a:spcPct val="106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Y-1215</a:t>
            </a:r>
          </a:p>
        </p:txBody>
      </p:sp>
      <p:pic>
        <p:nvPicPr>
          <p:cNvPr id="1032" name="Picture 8" descr="Tubastatin A Hydrochloride 1310693-92-5 | Tokyo Chemical Industry Co.,  Ltd.(APAC)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880" y="2967714"/>
            <a:ext cx="1697132" cy="16971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Dipyridamole.sv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4201" y="3143013"/>
            <a:ext cx="2095235" cy="17514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Rectangle 15"/>
          <p:cNvSpPr/>
          <p:nvPr/>
        </p:nvSpPr>
        <p:spPr>
          <a:xfrm>
            <a:off x="3258537" y="3119639"/>
            <a:ext cx="140388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pyridamole</a:t>
            </a:r>
            <a:r>
              <a:rPr lang="en-US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2790765" y="1743537"/>
            <a:ext cx="2213956" cy="288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marR="0">
              <a:lnSpc>
                <a:spcPct val="106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iraterone	</a:t>
            </a:r>
          </a:p>
        </p:txBody>
      </p:sp>
      <p:pic>
        <p:nvPicPr>
          <p:cNvPr id="1040" name="Picture 16" descr="Abiraterone acetate - Wikipedia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6026" y="1703221"/>
            <a:ext cx="1611008" cy="11196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DMNQ Chemical Structure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3465" y="535777"/>
            <a:ext cx="1065628" cy="10144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Rectangle 17"/>
          <p:cNvSpPr/>
          <p:nvPr/>
        </p:nvSpPr>
        <p:spPr>
          <a:xfrm>
            <a:off x="2771502" y="471982"/>
            <a:ext cx="1584442" cy="2742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marR="0">
              <a:lnSpc>
                <a:spcPct val="106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MNQ</a:t>
            </a:r>
          </a:p>
        </p:txBody>
      </p:sp>
      <p:pic>
        <p:nvPicPr>
          <p:cNvPr id="1046" name="Picture 22" descr="Riluzole (PK 26124) | Sodium Channel Inhibitor | MedChemExpress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142" b="32615"/>
          <a:stretch/>
        </p:blipFill>
        <p:spPr bwMode="auto">
          <a:xfrm>
            <a:off x="352349" y="5031975"/>
            <a:ext cx="2060131" cy="9605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Rectangle 18"/>
          <p:cNvSpPr/>
          <p:nvPr/>
        </p:nvSpPr>
        <p:spPr>
          <a:xfrm>
            <a:off x="1112659" y="4894498"/>
            <a:ext cx="1584442" cy="2742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marR="0">
              <a:lnSpc>
                <a:spcPct val="106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iluzole</a:t>
            </a:r>
          </a:p>
        </p:txBody>
      </p:sp>
      <p:sp>
        <p:nvSpPr>
          <p:cNvPr id="7" name="Rectangle 6"/>
          <p:cNvSpPr/>
          <p:nvPr/>
        </p:nvSpPr>
        <p:spPr>
          <a:xfrm>
            <a:off x="9433116" y="4681195"/>
            <a:ext cx="11079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C661</a:t>
            </a:r>
            <a:r>
              <a:rPr lang="en-US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endParaRPr lang="en-US"/>
          </a:p>
        </p:txBody>
      </p:sp>
      <p:pic>
        <p:nvPicPr>
          <p:cNvPr id="1058" name="Picture 34" descr="DC661 | 1872387-43-3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10623" y="4947530"/>
            <a:ext cx="4374490" cy="12454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8"/>
          <p:cNvSpPr/>
          <p:nvPr/>
        </p:nvSpPr>
        <p:spPr>
          <a:xfrm>
            <a:off x="1028979" y="3064038"/>
            <a:ext cx="1562159" cy="27424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457200" marR="0">
              <a:lnSpc>
                <a:spcPct val="106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ubastatin 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0" y="-9753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</a:p>
        </p:txBody>
      </p:sp>
      <p:sp>
        <p:nvSpPr>
          <p:cNvPr id="20" name="Rectangle 19"/>
          <p:cNvSpPr/>
          <p:nvPr/>
        </p:nvSpPr>
        <p:spPr>
          <a:xfrm>
            <a:off x="6093419" y="1679175"/>
            <a:ext cx="11079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linomycin</a:t>
            </a:r>
            <a:r>
              <a:rPr lang="en-US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270307" y="5025546"/>
            <a:ext cx="11079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lipram</a:t>
            </a:r>
            <a:r>
              <a:rPr lang="en-US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9115086" y="414064"/>
            <a:ext cx="203132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tulinic acid</a:t>
            </a:r>
            <a:r>
              <a:rPr lang="en-US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9115086" y="1845740"/>
            <a:ext cx="11079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pamycin</a:t>
            </a:r>
            <a:r>
              <a:rPr lang="en-US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093419" y="414064"/>
            <a:ext cx="11079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lareol</a:t>
            </a:r>
            <a:r>
              <a:rPr lang="en-US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endParaRPr lang="en-US"/>
          </a:p>
        </p:txBody>
      </p:sp>
      <p:pic>
        <p:nvPicPr>
          <p:cNvPr id="1026" name="Picture 2" descr="Salinomycin - Wikipedia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5372" y="1743537"/>
            <a:ext cx="2746516" cy="18906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Sirolimus - Wikipedia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49315" y="2346731"/>
            <a:ext cx="2043111" cy="18558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Betulinic acid.sv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79755" y="204563"/>
            <a:ext cx="1994063" cy="16552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Chloroquine and hydroxychloroquine | Podcast | Chemistry World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1393" y="4202613"/>
            <a:ext cx="2376915" cy="14898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Rectangle 22"/>
          <p:cNvSpPr/>
          <p:nvPr/>
        </p:nvSpPr>
        <p:spPr>
          <a:xfrm>
            <a:off x="6216863" y="3950942"/>
            <a:ext cx="203132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ydroxychloroquine</a:t>
            </a:r>
            <a:r>
              <a:rPr lang="en-US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	</a:t>
            </a:r>
            <a:endParaRPr lang="en-US"/>
          </a:p>
        </p:txBody>
      </p:sp>
      <p:pic>
        <p:nvPicPr>
          <p:cNvPr id="6" name="Picture 14" descr="Rolipram - Wikipedia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0185" y="5117036"/>
            <a:ext cx="2275102" cy="11508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6" descr="Sclareol - Wikidata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0874" y="360441"/>
            <a:ext cx="1023302" cy="12309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272990" y="6412539"/>
            <a:ext cx="118877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. S3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hemical structure of top pharmacologics identified in the HTS that increased proteasome ChT-like activity.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2021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47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00:59Z</dcterms:modified>
</cp:coreProperties>
</file>